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6" r:id="rId2"/>
  </p:sldIdLst>
  <p:sldSz cx="6858000" cy="9906000" type="A4"/>
  <p:notesSz cx="6797675" cy="98742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020FE"/>
    <a:srgbClr val="FDB67A"/>
    <a:srgbClr val="FD9950"/>
    <a:srgbClr val="F797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40" autoAdjust="0"/>
    <p:restoredTop sz="94660"/>
  </p:normalViewPr>
  <p:slideViewPr>
    <p:cSldViewPr snapToGrid="0">
      <p:cViewPr>
        <p:scale>
          <a:sx n="100" d="100"/>
          <a:sy n="100" d="100"/>
        </p:scale>
        <p:origin x="-972" y="-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953184-A5AB-41E1-AADF-A482A5B901D6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6313" y="1233488"/>
            <a:ext cx="2305050" cy="3333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51983"/>
            <a:ext cx="5438140" cy="3887986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690749-9845-429A-94A2-81F5EE9EA55F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969524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726843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483271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462429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8479441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557041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880758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4179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062917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017549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394864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800258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315467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image" Target="../media/image7.png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xmlns="" id="{FEB73DB4-E09B-4731-BB71-8AD7CDE6876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7065225"/>
              </p:ext>
            </p:extLst>
          </p:nvPr>
        </p:nvGraphicFramePr>
        <p:xfrm>
          <a:off x="751897" y="2651351"/>
          <a:ext cx="1366712" cy="15922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28" name="Prism 8" r:id="rId3" imgW="2125161" imgH="2477500" progId="Prism8.Document">
                  <p:embed/>
                </p:oleObj>
              </mc:Choice>
              <mc:Fallback>
                <p:oleObj name="Prism 8" r:id="rId3" imgW="2125161" imgH="2477500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xmlns="" id="{220059B9-9F52-475C-BA02-3885928C579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51897" y="2651351"/>
                        <a:ext cx="1366712" cy="15922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xmlns="" id="{6A62A984-6AD8-420B-9434-F33CBE91870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24498433"/>
              </p:ext>
            </p:extLst>
          </p:nvPr>
        </p:nvGraphicFramePr>
        <p:xfrm>
          <a:off x="2118609" y="2566875"/>
          <a:ext cx="1441234" cy="16767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29" name="Prism 8" r:id="rId5" imgW="2232121" imgH="2596350" progId="Prism8.Document">
                  <p:embed/>
                </p:oleObj>
              </mc:Choice>
              <mc:Fallback>
                <p:oleObj name="Prism 8" r:id="rId5" imgW="2232121" imgH="2596350" progId="Prism8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xmlns="" id="{6E9136DA-B14A-4285-AD56-B7E64596CC6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118609" y="2566875"/>
                        <a:ext cx="1441234" cy="16767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xmlns="" id="{2399F4C3-D3C1-42EC-8F11-02FECCA6FDB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12729122"/>
              </p:ext>
            </p:extLst>
          </p:nvPr>
        </p:nvGraphicFramePr>
        <p:xfrm>
          <a:off x="2255991" y="741417"/>
          <a:ext cx="1303852" cy="15922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30" name="Prism 8" r:id="rId7" imgW="2056735" imgH="2514235" progId="Prism8.Document">
                  <p:embed/>
                </p:oleObj>
              </mc:Choice>
              <mc:Fallback>
                <p:oleObj name="Prism 8" r:id="rId7" imgW="2056735" imgH="2514235" progId="Prism8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xmlns="" id="{78CA4558-CAC7-44B4-84F3-855148C9BE7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255991" y="741417"/>
                        <a:ext cx="1303852" cy="15922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xmlns="" id="{1233C0E3-1243-4AD0-A783-52C9DFC4CDB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59860148"/>
              </p:ext>
            </p:extLst>
          </p:nvPr>
        </p:nvGraphicFramePr>
        <p:xfrm>
          <a:off x="3647022" y="673098"/>
          <a:ext cx="1279533" cy="1728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31" name="Prism 8" r:id="rId9" imgW="1983628" imgH="2680266" progId="Prism8.Document">
                  <p:embed/>
                </p:oleObj>
              </mc:Choice>
              <mc:Fallback>
                <p:oleObj name="Prism 8" r:id="rId9" imgW="1983628" imgH="2680266" progId="Prism8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xmlns="" id="{0CF72FF7-CBF5-4D02-8E7D-28C8C53D470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647022" y="673098"/>
                        <a:ext cx="1279533" cy="1728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xmlns="" id="{B3141712-EBDE-4328-90E5-806CA5AC19D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16643691"/>
              </p:ext>
            </p:extLst>
          </p:nvPr>
        </p:nvGraphicFramePr>
        <p:xfrm>
          <a:off x="876158" y="718001"/>
          <a:ext cx="1336244" cy="163909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32" name="Prism 8" r:id="rId11" imgW="2049172" imgH="2514235" progId="Prism8.Document">
                  <p:embed/>
                </p:oleObj>
              </mc:Choice>
              <mc:Fallback>
                <p:oleObj name="Prism 8" r:id="rId11" imgW="2049172" imgH="2514235" progId="Prism8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xmlns="" id="{B1F8D308-6A24-44F2-B663-3A9BCDD23A7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876158" y="718001"/>
                        <a:ext cx="1336244" cy="163909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xmlns="" id="{96D6E4F2-7D8B-4AC3-B605-F25E7659C9F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67276389"/>
              </p:ext>
            </p:extLst>
          </p:nvPr>
        </p:nvGraphicFramePr>
        <p:xfrm>
          <a:off x="3559843" y="2651351"/>
          <a:ext cx="1366712" cy="16145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33" name="Prism 8" r:id="rId13" imgW="2154332" imgH="2547730" progId="Prism8.Document">
                  <p:embed/>
                </p:oleObj>
              </mc:Choice>
              <mc:Fallback>
                <p:oleObj name="Prism 8" r:id="rId13" imgW="2154332" imgH="2547730" progId="Prism8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xmlns="" id="{DD1AF6D1-5599-4082-B7F8-8DE0510B5AE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559843" y="2651351"/>
                        <a:ext cx="1366712" cy="16145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0" name="Picture 9">
            <a:extLst>
              <a:ext uri="{FF2B5EF4-FFF2-40B4-BE49-F238E27FC236}">
                <a16:creationId xmlns:a16="http://schemas.microsoft.com/office/drawing/2014/main" xmlns="" id="{8F783CC3-FA18-44D6-9787-82584802F908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013734" y="821979"/>
            <a:ext cx="1443924" cy="701335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AD867E06-2D7E-4096-99B9-EAE7A9A82FE5}"/>
              </a:ext>
            </a:extLst>
          </p:cNvPr>
          <p:cNvSpPr txBox="1"/>
          <p:nvPr/>
        </p:nvSpPr>
        <p:spPr>
          <a:xfrm>
            <a:off x="84220" y="216568"/>
            <a:ext cx="2875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ry Figure 5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0052C6D2-8165-4490-B00C-31A9E9045458}"/>
              </a:ext>
            </a:extLst>
          </p:cNvPr>
          <p:cNvSpPr txBox="1"/>
          <p:nvPr/>
        </p:nvSpPr>
        <p:spPr>
          <a:xfrm>
            <a:off x="751897" y="67086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4366EC93-732E-46AB-8C92-703E40D5E868}"/>
              </a:ext>
            </a:extLst>
          </p:cNvPr>
          <p:cNvSpPr txBox="1"/>
          <p:nvPr/>
        </p:nvSpPr>
        <p:spPr>
          <a:xfrm>
            <a:off x="2208331" y="670866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B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84FFAC1D-D02B-47EE-95D1-3E7662051116}"/>
              </a:ext>
            </a:extLst>
          </p:cNvPr>
          <p:cNvSpPr txBox="1"/>
          <p:nvPr/>
        </p:nvSpPr>
        <p:spPr>
          <a:xfrm>
            <a:off x="3648882" y="670866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6197C8D7-37FD-4EA6-9B7E-C168EF3A3BDC}"/>
              </a:ext>
            </a:extLst>
          </p:cNvPr>
          <p:cNvSpPr txBox="1"/>
          <p:nvPr/>
        </p:nvSpPr>
        <p:spPr>
          <a:xfrm>
            <a:off x="751897" y="2637307"/>
            <a:ext cx="2984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D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89BC2CF1-34B7-4C26-8D14-56897C5CF28B}"/>
              </a:ext>
            </a:extLst>
          </p:cNvPr>
          <p:cNvSpPr txBox="1"/>
          <p:nvPr/>
        </p:nvSpPr>
        <p:spPr>
          <a:xfrm>
            <a:off x="2208331" y="2637307"/>
            <a:ext cx="272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E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DBC7298B-0853-42A2-A690-DF317B753674}"/>
              </a:ext>
            </a:extLst>
          </p:cNvPr>
          <p:cNvSpPr txBox="1"/>
          <p:nvPr/>
        </p:nvSpPr>
        <p:spPr>
          <a:xfrm>
            <a:off x="3648882" y="2637307"/>
            <a:ext cx="2664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F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xmlns="" id="{A9361D8F-DBEE-4C9D-BA9C-8D00D8BE01CB}"/>
              </a:ext>
            </a:extLst>
          </p:cNvPr>
          <p:cNvSpPr/>
          <p:nvPr/>
        </p:nvSpPr>
        <p:spPr>
          <a:xfrm>
            <a:off x="80210" y="4680003"/>
            <a:ext cx="6697580" cy="15695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Supplementary Figure 5 – Immune cell content in CT-26 responders and non-responders</a:t>
            </a:r>
            <a:endParaRPr lang="en-GB" sz="1200" dirty="0"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GB" sz="1200" dirty="0"/>
              <a:t>CT-26 tumors treated with </a:t>
            </a:r>
            <a:r>
              <a:rPr lang="el-GR" sz="1200" dirty="0">
                <a:cs typeface="Arial" panose="020B0604020202020204" pitchFamily="34" charset="0"/>
              </a:rPr>
              <a:t>α</a:t>
            </a:r>
            <a:r>
              <a:rPr lang="en-GB" sz="1200" dirty="0">
                <a:cs typeface="Arial" panose="020B0604020202020204" pitchFamily="34" charset="0"/>
              </a:rPr>
              <a:t>PD-L1 + </a:t>
            </a:r>
            <a:r>
              <a:rPr lang="el-GR" sz="1200" dirty="0">
                <a:cs typeface="Arial" panose="020B0604020202020204" pitchFamily="34" charset="0"/>
              </a:rPr>
              <a:t>α</a:t>
            </a:r>
            <a:r>
              <a:rPr lang="en-GB" sz="1200" dirty="0">
                <a:cs typeface="Arial" panose="020B0604020202020204" pitchFamily="34" charset="0"/>
              </a:rPr>
              <a:t>CTLA-4, collected on day 15 after implant, and were divided into responders and non-responders, by taking tumors smaller than the smallest vehicle control (0.187 mm</a:t>
            </a:r>
            <a:r>
              <a:rPr lang="en-GB" sz="1200" baseline="30000" dirty="0">
                <a:cs typeface="Arial" panose="020B0604020202020204" pitchFamily="34" charset="0"/>
              </a:rPr>
              <a:t>3</a:t>
            </a:r>
            <a:r>
              <a:rPr lang="en-GB" sz="1200" dirty="0">
                <a:cs typeface="Arial" panose="020B0604020202020204" pitchFamily="34" charset="0"/>
              </a:rPr>
              <a:t>) as responders and anything larger as a non-responder.  Flow cytometry data for </a:t>
            </a:r>
            <a:r>
              <a:rPr lang="en-GB" sz="1200" b="1" dirty="0"/>
              <a:t>(A)</a:t>
            </a:r>
            <a:r>
              <a:rPr lang="en-GB" sz="1200" dirty="0"/>
              <a:t> CD8+ T-cells, </a:t>
            </a:r>
            <a:r>
              <a:rPr lang="en-GB" sz="1200" b="1" dirty="0"/>
              <a:t>(B)</a:t>
            </a:r>
            <a:r>
              <a:rPr lang="en-GB" sz="1200" dirty="0"/>
              <a:t> CD4+ T-cells, </a:t>
            </a:r>
            <a:r>
              <a:rPr lang="en-GB" sz="1200" b="1" dirty="0"/>
              <a:t>(C)</a:t>
            </a:r>
            <a:r>
              <a:rPr lang="en-GB" sz="1200" dirty="0"/>
              <a:t> Tregs, </a:t>
            </a:r>
            <a:r>
              <a:rPr lang="en-GB" sz="1200" b="1" dirty="0"/>
              <a:t>(D)</a:t>
            </a:r>
            <a:r>
              <a:rPr lang="en-GB" sz="1200" dirty="0"/>
              <a:t> CD11b+ myeloid cells, </a:t>
            </a:r>
            <a:r>
              <a:rPr lang="en-GB" sz="1200" b="1" dirty="0"/>
              <a:t>(E)</a:t>
            </a:r>
            <a:r>
              <a:rPr lang="en-GB" sz="1200" dirty="0"/>
              <a:t> F4/80 myeloid cells, and </a:t>
            </a:r>
            <a:r>
              <a:rPr lang="en-GB" sz="1200" b="1" dirty="0"/>
              <a:t>(F)</a:t>
            </a:r>
            <a:r>
              <a:rPr lang="en-GB" sz="1200" dirty="0"/>
              <a:t> DCs populations are shown. n= 10 (vehicle), 9 (Responder, R), 10 (non-responder, NR).  Statistical significance is indicated as *p&lt;0.05, **p&lt;0.01,***p&lt;0.001, ****p&lt;0.0001.</a:t>
            </a:r>
            <a:endParaRPr lang="en-GB" sz="12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20167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420</TotalTime>
  <Words>149</Words>
  <Application>Microsoft Office PowerPoint</Application>
  <PresentationFormat>A4 Paper (210x297 mm)</PresentationFormat>
  <Paragraphs>9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 8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ylor, Molly</dc:creator>
  <cp:lastModifiedBy>Azarse, Elma Kadile</cp:lastModifiedBy>
  <cp:revision>302</cp:revision>
  <cp:lastPrinted>2019-02-05T09:56:44Z</cp:lastPrinted>
  <dcterms:created xsi:type="dcterms:W3CDTF">2018-07-09T15:32:49Z</dcterms:created>
  <dcterms:modified xsi:type="dcterms:W3CDTF">2019-11-21T12:51:51Z</dcterms:modified>
</cp:coreProperties>
</file>